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62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FFFFFF"/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60" autoAdjust="0"/>
    <p:restoredTop sz="97489" autoAdjust="0"/>
  </p:normalViewPr>
  <p:slideViewPr>
    <p:cSldViewPr snapToGrid="0">
      <p:cViewPr varScale="1">
        <p:scale>
          <a:sx n="84" d="100"/>
          <a:sy n="84" d="100"/>
        </p:scale>
        <p:origin x="227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8C0522-AB7F-46CE-BAA3-DA585B3AA3D9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C6EEF1-1D8B-4DEE-85BE-D35FDFEF363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64723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58217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6581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7647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85755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44719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88646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7658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59412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72387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83099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59707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96165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62AABC54-4C36-4D66-A677-4A7F70478555}"/>
              </a:ext>
            </a:extLst>
          </p:cNvPr>
          <p:cNvSpPr txBox="1"/>
          <p:nvPr/>
        </p:nvSpPr>
        <p:spPr>
          <a:xfrm>
            <a:off x="129239" y="42763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  <a:endParaRPr lang="en-DE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CBA52FB-3918-4EF3-952A-91270D0A6D80}"/>
              </a:ext>
            </a:extLst>
          </p:cNvPr>
          <p:cNvSpPr txBox="1"/>
          <p:nvPr/>
        </p:nvSpPr>
        <p:spPr>
          <a:xfrm>
            <a:off x="758222" y="22064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  <a:endParaRPr lang="en-DE" dirty="0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52A111B-493E-420E-8858-E1ED903F2132}"/>
              </a:ext>
            </a:extLst>
          </p:cNvPr>
          <p:cNvGrpSpPr/>
          <p:nvPr/>
        </p:nvGrpSpPr>
        <p:grpSpPr>
          <a:xfrm>
            <a:off x="821835" y="2284572"/>
            <a:ext cx="3270105" cy="2207975"/>
            <a:chOff x="6186878" y="3772365"/>
            <a:chExt cx="2957122" cy="1851008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9C4E6A0-2903-44F7-AD50-A47475BDF7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86878" y="3861683"/>
              <a:ext cx="2957122" cy="1761690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7165EF7-936F-48FE-8DAD-CFC2EA4A985F}"/>
                </a:ext>
              </a:extLst>
            </p:cNvPr>
            <p:cNvGrpSpPr/>
            <p:nvPr/>
          </p:nvGrpSpPr>
          <p:grpSpPr>
            <a:xfrm>
              <a:off x="6626147" y="3772365"/>
              <a:ext cx="1901231" cy="206416"/>
              <a:chOff x="2669269" y="3600420"/>
              <a:chExt cx="2548901" cy="269016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315DD06-A873-4D55-8677-4313FAB7A54F}"/>
                  </a:ext>
                </a:extLst>
              </p:cNvPr>
              <p:cNvSpPr txBox="1"/>
              <p:nvPr/>
            </p:nvSpPr>
            <p:spPr>
              <a:xfrm>
                <a:off x="2669269" y="3600423"/>
                <a:ext cx="550367" cy="2690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Day1</a:t>
                </a:r>
                <a:endParaRPr lang="en-DE" sz="1000" b="1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1E25D77-F480-43CB-87E1-E798E6B01DCD}"/>
                  </a:ext>
                </a:extLst>
              </p:cNvPr>
              <p:cNvSpPr txBox="1"/>
              <p:nvPr/>
            </p:nvSpPr>
            <p:spPr>
              <a:xfrm>
                <a:off x="3307540" y="3600423"/>
                <a:ext cx="550367" cy="2690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Day3</a:t>
                </a:r>
                <a:endParaRPr lang="en-DE" sz="1000" b="1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2EAF8E5-9815-4F1C-BBD8-9FA3CDA7E64A}"/>
                  </a:ext>
                </a:extLst>
              </p:cNvPr>
              <p:cNvSpPr txBox="1"/>
              <p:nvPr/>
            </p:nvSpPr>
            <p:spPr>
              <a:xfrm>
                <a:off x="3970171" y="3600422"/>
                <a:ext cx="550367" cy="2690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Day7</a:t>
                </a:r>
                <a:endParaRPr lang="en-DE" sz="1000" b="1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9B7AF56-7390-458C-9FF9-1CBAC5C9FEB0}"/>
                  </a:ext>
                </a:extLst>
              </p:cNvPr>
              <p:cNvSpPr txBox="1"/>
              <p:nvPr/>
            </p:nvSpPr>
            <p:spPr>
              <a:xfrm>
                <a:off x="4588123" y="3600420"/>
                <a:ext cx="630047" cy="2690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Day15</a:t>
                </a:r>
                <a:endParaRPr lang="en-DE" sz="1000" b="1" dirty="0"/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DF767143-01C8-4B87-8352-C89FD3165C53}"/>
              </a:ext>
            </a:extLst>
          </p:cNvPr>
          <p:cNvGrpSpPr>
            <a:grpSpLocks noChangeAspect="1"/>
          </p:cNvGrpSpPr>
          <p:nvPr/>
        </p:nvGrpSpPr>
        <p:grpSpPr>
          <a:xfrm>
            <a:off x="155731" y="487618"/>
            <a:ext cx="6582983" cy="1519619"/>
            <a:chOff x="212715" y="4015536"/>
            <a:chExt cx="5926169" cy="136390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33EF899-78B0-4F6D-B95E-B414DF60B019}"/>
                </a:ext>
              </a:extLst>
            </p:cNvPr>
            <p:cNvGrpSpPr/>
            <p:nvPr/>
          </p:nvGrpSpPr>
          <p:grpSpPr>
            <a:xfrm>
              <a:off x="439367" y="4015536"/>
              <a:ext cx="5699517" cy="1363908"/>
              <a:chOff x="140362" y="4071254"/>
              <a:chExt cx="5699517" cy="1363908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43ACB078-F9A6-42BD-9BA0-FB25854BED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933" t="17660" b="-1"/>
              <a:stretch/>
            </p:blipFill>
            <p:spPr>
              <a:xfrm>
                <a:off x="140362" y="4319162"/>
                <a:ext cx="5699517" cy="1116000"/>
              </a:xfrm>
              <a:prstGeom prst="rect">
                <a:avLst/>
              </a:prstGeom>
            </p:spPr>
          </p:pic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AFE0099B-7DD7-4225-ACE4-8F4AC4125FAE}"/>
                  </a:ext>
                </a:extLst>
              </p:cNvPr>
              <p:cNvSpPr/>
              <p:nvPr/>
            </p:nvSpPr>
            <p:spPr>
              <a:xfrm>
                <a:off x="172767" y="4072444"/>
                <a:ext cx="1084759" cy="2255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000" b="1" dirty="0">
                    <a:solidFill>
                      <a:schemeClr val="tx1"/>
                    </a:solidFill>
                  </a:rPr>
                  <a:t>SHAM</a:t>
                </a:r>
                <a:endParaRPr lang="en-DE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11CAB6D7-1482-491A-BA87-6D23B735C1DF}"/>
                  </a:ext>
                </a:extLst>
              </p:cNvPr>
              <p:cNvSpPr/>
              <p:nvPr/>
            </p:nvSpPr>
            <p:spPr>
              <a:xfrm>
                <a:off x="1326825" y="4071254"/>
                <a:ext cx="1093122" cy="2255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000" b="1" dirty="0">
                    <a:solidFill>
                      <a:schemeClr val="tx1"/>
                    </a:solidFill>
                  </a:rPr>
                  <a:t>1 day after CHI</a:t>
                </a:r>
                <a:endParaRPr lang="en-DE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A7D6DE32-019D-4FDB-A81C-5D168EED9A79}"/>
                  </a:ext>
                </a:extLst>
              </p:cNvPr>
              <p:cNvSpPr/>
              <p:nvPr/>
            </p:nvSpPr>
            <p:spPr>
              <a:xfrm>
                <a:off x="2459250" y="4072069"/>
                <a:ext cx="1093122" cy="2263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000" b="1" dirty="0">
                    <a:solidFill>
                      <a:schemeClr val="tx1"/>
                    </a:solidFill>
                  </a:rPr>
                  <a:t>3 days after CHI</a:t>
                </a:r>
                <a:endParaRPr lang="en-DE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932BAE27-E85D-4ACB-A880-540813E3D919}"/>
                  </a:ext>
                </a:extLst>
              </p:cNvPr>
              <p:cNvSpPr/>
              <p:nvPr/>
            </p:nvSpPr>
            <p:spPr>
              <a:xfrm>
                <a:off x="3592172" y="4071693"/>
                <a:ext cx="1093122" cy="22705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000" b="1" dirty="0">
                    <a:solidFill>
                      <a:schemeClr val="tx1"/>
                    </a:solidFill>
                  </a:rPr>
                  <a:t>7 days after CHI</a:t>
                </a:r>
                <a:endParaRPr lang="en-DE" sz="10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A97F11BD-A0D5-4F3D-9C39-311ED54123C2}"/>
                  </a:ext>
                </a:extLst>
              </p:cNvPr>
              <p:cNvSpPr/>
              <p:nvPr/>
            </p:nvSpPr>
            <p:spPr>
              <a:xfrm>
                <a:off x="4743398" y="4072415"/>
                <a:ext cx="1093122" cy="2263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000" b="1" dirty="0">
                    <a:solidFill>
                      <a:schemeClr val="tx1"/>
                    </a:solidFill>
                  </a:rPr>
                  <a:t>15 days after CHI</a:t>
                </a:r>
                <a:endParaRPr lang="en-DE" sz="1000" b="1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733BE4E9-27F8-47A1-96B8-E8B579F5F94A}"/>
                </a:ext>
              </a:extLst>
            </p:cNvPr>
            <p:cNvSpPr/>
            <p:nvPr/>
          </p:nvSpPr>
          <p:spPr>
            <a:xfrm rot="16200000">
              <a:off x="-216888" y="4724288"/>
              <a:ext cx="1084759" cy="2255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200" b="1" dirty="0">
                  <a:solidFill>
                    <a:schemeClr val="bg1">
                      <a:lumMod val="50000"/>
                    </a:schemeClr>
                  </a:solidFill>
                </a:rPr>
                <a:t>Iba1</a:t>
              </a:r>
              <a:r>
                <a:rPr lang="de-DE" sz="1200" b="1" dirty="0">
                  <a:solidFill>
                    <a:schemeClr val="tx1"/>
                  </a:solidFill>
                </a:rPr>
                <a:t> </a:t>
              </a:r>
              <a:r>
                <a:rPr lang="de-DE" sz="1200" b="1" dirty="0">
                  <a:solidFill>
                    <a:srgbClr val="00B050"/>
                  </a:solidFill>
                </a:rPr>
                <a:t>BrdU</a:t>
              </a:r>
              <a:endParaRPr lang="en-DE" sz="1200" b="1" dirty="0">
                <a:solidFill>
                  <a:srgbClr val="00B050"/>
                </a:solidFill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B89EB8F7-E86F-8536-DE43-7DB14129FA53}"/>
              </a:ext>
            </a:extLst>
          </p:cNvPr>
          <p:cNvSpPr txBox="1"/>
          <p:nvPr/>
        </p:nvSpPr>
        <p:spPr>
          <a:xfrm>
            <a:off x="281006" y="4651453"/>
            <a:ext cx="6331211" cy="33634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5: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creased proliferation of microglia in the contralateral side after CHI. (a) immunohistochemical staining shows the morphology of Iba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and their colocalization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the contralateral side of the brain after TBI. A representative sham mouse that receive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15 days is shown as comparison. (b) The column graph shows the total Iba1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for each of the analyzed time points that were divided into proliferativ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green), and non-proliferativ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(orange). An increase in double-positive cells is observed in the contralateral side 3 days, 7 days, and 15 days after trauma. Statistical analysis: Two-Way ANOVA with Tuckey post-hoc test for multiple comparisons. **p &lt; 0.01. Data are presented as mean ± SEM. 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6B2A113-ECB5-2232-F601-B54D5E66B86A}"/>
              </a:ext>
            </a:extLst>
          </p:cNvPr>
          <p:cNvSpPr txBox="1"/>
          <p:nvPr/>
        </p:nvSpPr>
        <p:spPr>
          <a:xfrm>
            <a:off x="480656" y="179179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/>
                </a:solidFill>
              </a:rPr>
              <a:t>100 µm</a:t>
            </a:r>
            <a:endParaRPr lang="de-DE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3738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3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b meeting 28.04.21</dc:title>
  <dc:creator>Ester Nespoli</dc:creator>
  <cp:lastModifiedBy>leda.dimou</cp:lastModifiedBy>
  <cp:revision>599</cp:revision>
  <cp:lastPrinted>2022-03-07T17:10:50Z</cp:lastPrinted>
  <dcterms:created xsi:type="dcterms:W3CDTF">2021-04-26T10:16:35Z</dcterms:created>
  <dcterms:modified xsi:type="dcterms:W3CDTF">2023-12-22T16:38:21Z</dcterms:modified>
</cp:coreProperties>
</file>